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83" r:id="rId2"/>
    <p:sldId id="267" r:id="rId3"/>
    <p:sldId id="280" r:id="rId4"/>
    <p:sldId id="269" r:id="rId5"/>
  </p:sldIdLst>
  <p:sldSz cx="6858000" cy="9906000" type="A4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C55A11"/>
    <a:srgbClr val="AAAAAA"/>
    <a:srgbClr val="FFFFFF"/>
    <a:srgbClr val="008000"/>
    <a:srgbClr val="009600"/>
    <a:srgbClr val="0000FF"/>
    <a:srgbClr val="3B3BFF"/>
    <a:srgbClr val="D47203"/>
    <a:srgbClr val="FF737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530" autoAdjust="0"/>
    <p:restoredTop sz="76847" autoAdjust="0"/>
  </p:normalViewPr>
  <p:slideViewPr>
    <p:cSldViewPr snapToGrid="0">
      <p:cViewPr varScale="1">
        <p:scale>
          <a:sx n="59" d="100"/>
          <a:sy n="59" d="100"/>
        </p:scale>
        <p:origin x="3432" y="78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052" cy="498714"/>
          </a:xfrm>
          <a:prstGeom prst="rect">
            <a:avLst/>
          </a:prstGeom>
        </p:spPr>
        <p:txBody>
          <a:bodyPr vert="horz" lIns="91486" tIns="45743" rIns="91486" bIns="45743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5561" y="0"/>
            <a:ext cx="2950051" cy="498714"/>
          </a:xfrm>
          <a:prstGeom prst="rect">
            <a:avLst/>
          </a:prstGeom>
        </p:spPr>
        <p:txBody>
          <a:bodyPr vert="horz" lIns="91486" tIns="45743" rIns="91486" bIns="45743" rtlCol="0"/>
          <a:lstStyle>
            <a:lvl1pPr algn="r">
              <a:defRPr sz="1200"/>
            </a:lvl1pPr>
          </a:lstStyle>
          <a:p>
            <a:fld id="{E6C6C105-1B0D-4245-9036-F75DEEE6F7CC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1425"/>
            <a:ext cx="2322512" cy="33543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86" tIns="45743" rIns="91486" bIns="45743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1515" y="4783843"/>
            <a:ext cx="5445760" cy="3913475"/>
          </a:xfrm>
          <a:prstGeom prst="rect">
            <a:avLst/>
          </a:prstGeom>
        </p:spPr>
        <p:txBody>
          <a:bodyPr vert="horz" lIns="91486" tIns="45743" rIns="91486" bIns="45743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625"/>
            <a:ext cx="2950052" cy="498714"/>
          </a:xfrm>
          <a:prstGeom prst="rect">
            <a:avLst/>
          </a:prstGeom>
        </p:spPr>
        <p:txBody>
          <a:bodyPr vert="horz" lIns="91486" tIns="45743" rIns="91486" bIns="45743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5561" y="9440625"/>
            <a:ext cx="2950051" cy="498714"/>
          </a:xfrm>
          <a:prstGeom prst="rect">
            <a:avLst/>
          </a:prstGeom>
        </p:spPr>
        <p:txBody>
          <a:bodyPr vert="horz" lIns="91486" tIns="45743" rIns="91486" bIns="45743" rtlCol="0" anchor="b"/>
          <a:lstStyle>
            <a:lvl1pPr algn="r">
              <a:defRPr sz="1200"/>
            </a:lvl1pPr>
          </a:lstStyle>
          <a:p>
            <a:fld id="{95D292D2-AB8A-4244-A20C-83B1B8AE15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93172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5" indent="0" algn="ctr">
              <a:buNone/>
              <a:defRPr sz="1500"/>
            </a:lvl2pPr>
            <a:lvl3pPr marL="685750" indent="0" algn="ctr">
              <a:buNone/>
              <a:defRPr sz="1350"/>
            </a:lvl3pPr>
            <a:lvl4pPr marL="1028625" indent="0" algn="ctr">
              <a:buNone/>
              <a:defRPr sz="1200"/>
            </a:lvl4pPr>
            <a:lvl5pPr marL="1371500" indent="0" algn="ctr">
              <a:buNone/>
              <a:defRPr sz="1200"/>
            </a:lvl5pPr>
            <a:lvl6pPr marL="1714376" indent="0" algn="ctr">
              <a:buNone/>
              <a:defRPr sz="1200"/>
            </a:lvl6pPr>
            <a:lvl7pPr marL="2057251" indent="0" algn="ctr">
              <a:buNone/>
              <a:defRPr sz="1200"/>
            </a:lvl7pPr>
            <a:lvl8pPr marL="2400126" indent="0" algn="ctr">
              <a:buNone/>
              <a:defRPr sz="1200"/>
            </a:lvl8pPr>
            <a:lvl9pPr marL="2743001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5901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3513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6748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6812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5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2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7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5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0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0042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1704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5" indent="0">
              <a:buNone/>
              <a:defRPr sz="1500" b="1"/>
            </a:lvl2pPr>
            <a:lvl3pPr marL="685750" indent="0">
              <a:buNone/>
              <a:defRPr sz="1350" b="1"/>
            </a:lvl3pPr>
            <a:lvl4pPr marL="1028625" indent="0">
              <a:buNone/>
              <a:defRPr sz="1200" b="1"/>
            </a:lvl4pPr>
            <a:lvl5pPr marL="1371500" indent="0">
              <a:buNone/>
              <a:defRPr sz="1200" b="1"/>
            </a:lvl5pPr>
            <a:lvl6pPr marL="1714376" indent="0">
              <a:buNone/>
              <a:defRPr sz="1200" b="1"/>
            </a:lvl6pPr>
            <a:lvl7pPr marL="2057251" indent="0">
              <a:buNone/>
              <a:defRPr sz="1200" b="1"/>
            </a:lvl7pPr>
            <a:lvl8pPr marL="2400126" indent="0">
              <a:buNone/>
              <a:defRPr sz="1200" b="1"/>
            </a:lvl8pPr>
            <a:lvl9pPr marL="274300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5" indent="0">
              <a:buNone/>
              <a:defRPr sz="1500" b="1"/>
            </a:lvl2pPr>
            <a:lvl3pPr marL="685750" indent="0">
              <a:buNone/>
              <a:defRPr sz="1350" b="1"/>
            </a:lvl3pPr>
            <a:lvl4pPr marL="1028625" indent="0">
              <a:buNone/>
              <a:defRPr sz="1200" b="1"/>
            </a:lvl4pPr>
            <a:lvl5pPr marL="1371500" indent="0">
              <a:buNone/>
              <a:defRPr sz="1200" b="1"/>
            </a:lvl5pPr>
            <a:lvl6pPr marL="1714376" indent="0">
              <a:buNone/>
              <a:defRPr sz="1200" b="1"/>
            </a:lvl6pPr>
            <a:lvl7pPr marL="2057251" indent="0">
              <a:buNone/>
              <a:defRPr sz="1200" b="1"/>
            </a:lvl7pPr>
            <a:lvl8pPr marL="2400126" indent="0">
              <a:buNone/>
              <a:defRPr sz="1200" b="1"/>
            </a:lvl8pPr>
            <a:lvl9pPr marL="274300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2783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6974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7295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5" indent="0">
              <a:buNone/>
              <a:defRPr sz="1050"/>
            </a:lvl2pPr>
            <a:lvl3pPr marL="685750" indent="0">
              <a:buNone/>
              <a:defRPr sz="900"/>
            </a:lvl3pPr>
            <a:lvl4pPr marL="1028625" indent="0">
              <a:buNone/>
              <a:defRPr sz="750"/>
            </a:lvl4pPr>
            <a:lvl5pPr marL="1371500" indent="0">
              <a:buNone/>
              <a:defRPr sz="750"/>
            </a:lvl5pPr>
            <a:lvl6pPr marL="1714376" indent="0">
              <a:buNone/>
              <a:defRPr sz="750"/>
            </a:lvl6pPr>
            <a:lvl7pPr marL="2057251" indent="0">
              <a:buNone/>
              <a:defRPr sz="750"/>
            </a:lvl7pPr>
            <a:lvl8pPr marL="2400126" indent="0">
              <a:buNone/>
              <a:defRPr sz="750"/>
            </a:lvl8pPr>
            <a:lvl9pPr marL="2743001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8010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5" indent="0">
              <a:buNone/>
              <a:defRPr sz="2100"/>
            </a:lvl2pPr>
            <a:lvl3pPr marL="685750" indent="0">
              <a:buNone/>
              <a:defRPr sz="1800"/>
            </a:lvl3pPr>
            <a:lvl4pPr marL="1028625" indent="0">
              <a:buNone/>
              <a:defRPr sz="1500"/>
            </a:lvl4pPr>
            <a:lvl5pPr marL="1371500" indent="0">
              <a:buNone/>
              <a:defRPr sz="1500"/>
            </a:lvl5pPr>
            <a:lvl6pPr marL="1714376" indent="0">
              <a:buNone/>
              <a:defRPr sz="1500"/>
            </a:lvl6pPr>
            <a:lvl7pPr marL="2057251" indent="0">
              <a:buNone/>
              <a:defRPr sz="1500"/>
            </a:lvl7pPr>
            <a:lvl8pPr marL="2400126" indent="0">
              <a:buNone/>
              <a:defRPr sz="1500"/>
            </a:lvl8pPr>
            <a:lvl9pPr marL="2743001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5" indent="0">
              <a:buNone/>
              <a:defRPr sz="1050"/>
            </a:lvl2pPr>
            <a:lvl3pPr marL="685750" indent="0">
              <a:buNone/>
              <a:defRPr sz="900"/>
            </a:lvl3pPr>
            <a:lvl4pPr marL="1028625" indent="0">
              <a:buNone/>
              <a:defRPr sz="750"/>
            </a:lvl4pPr>
            <a:lvl5pPr marL="1371500" indent="0">
              <a:buNone/>
              <a:defRPr sz="750"/>
            </a:lvl5pPr>
            <a:lvl6pPr marL="1714376" indent="0">
              <a:buNone/>
              <a:defRPr sz="750"/>
            </a:lvl6pPr>
            <a:lvl7pPr marL="2057251" indent="0">
              <a:buNone/>
              <a:defRPr sz="750"/>
            </a:lvl7pPr>
            <a:lvl8pPr marL="2400126" indent="0">
              <a:buNone/>
              <a:defRPr sz="750"/>
            </a:lvl8pPr>
            <a:lvl9pPr marL="2743001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0525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3DF538-4E77-46CF-9640-55811A0C52D3}" type="datetimeFigureOut">
              <a:rPr lang="ko-KR" altLang="en-US" smtClean="0"/>
              <a:t>2019-1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B6EAB3-4D6A-4994-8112-64E136366A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2279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5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8" indent="-171438" algn="l" defTabSz="68575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13" indent="-171438" algn="l" defTabSz="68575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88" indent="-171438" algn="l" defTabSz="68575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63" indent="-171438" algn="l" defTabSz="68575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38" indent="-171438" algn="l" defTabSz="68575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13" indent="-171438" algn="l" defTabSz="68575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88" indent="-171438" algn="l" defTabSz="68575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63" indent="-171438" algn="l" defTabSz="68575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38" indent="-171438" algn="l" defTabSz="68575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5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50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25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00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76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51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26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01" algn="l" defTabSz="68575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82958" y="96029"/>
            <a:ext cx="6732104" cy="4160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Mutational signature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 preferRelativeResize="0">
            <a:picLocks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149"/>
          <a:stretch/>
        </p:blipFill>
        <p:spPr>
          <a:xfrm>
            <a:off x="3566302" y="935010"/>
            <a:ext cx="3032369" cy="2527200"/>
          </a:xfrm>
          <a:prstGeom prst="rect">
            <a:avLst/>
          </a:prstGeom>
        </p:spPr>
      </p:pic>
      <p:pic>
        <p:nvPicPr>
          <p:cNvPr id="4" name="그림 3"/>
          <p:cNvPicPr preferRelativeResize="0">
            <a:picLocks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149"/>
          <a:stretch/>
        </p:blipFill>
        <p:spPr>
          <a:xfrm>
            <a:off x="533933" y="935010"/>
            <a:ext cx="3032369" cy="25272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99262" y="744430"/>
            <a:ext cx="448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334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.</a:t>
            </a:r>
            <a:endParaRPr kumimoji="0" lang="ko-KR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16" name="그룹 15"/>
          <p:cNvGrpSpPr/>
          <p:nvPr/>
        </p:nvGrpSpPr>
        <p:grpSpPr>
          <a:xfrm>
            <a:off x="299262" y="3652566"/>
            <a:ext cx="6032958" cy="2344388"/>
            <a:chOff x="299262" y="3461985"/>
            <a:chExt cx="6032958" cy="2344388"/>
          </a:xfrm>
        </p:grpSpPr>
        <p:sp>
          <p:nvSpPr>
            <p:cNvPr id="7" name="TextBox 6"/>
            <p:cNvSpPr txBox="1"/>
            <p:nvPr/>
          </p:nvSpPr>
          <p:spPr>
            <a:xfrm>
              <a:off x="299262" y="3461985"/>
              <a:ext cx="448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334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200" b="1" noProof="0" dirty="0"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B</a:t>
              </a: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.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3933" y="3637034"/>
              <a:ext cx="2725030" cy="2009926"/>
            </a:xfrm>
            <a:prstGeom prst="rect">
              <a:avLst/>
            </a:prstGeom>
          </p:spPr>
        </p:pic>
        <p:pic>
          <p:nvPicPr>
            <p:cNvPr id="5" name="그림 4"/>
            <p:cNvPicPr preferRelativeResize="0"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95150" y="3531173"/>
              <a:ext cx="2737070" cy="22752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3433491" y="3461985"/>
              <a:ext cx="448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334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200" b="1" dirty="0"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</a:t>
              </a:r>
              <a:r>
                <a:rPr kumimoji="0" lang="en-US" altLang="ko-K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.</a:t>
              </a:r>
              <a:endParaRPr kumimoji="0" lang="ko-KR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299262" y="6025273"/>
            <a:ext cx="448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334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</a:t>
            </a: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</a:t>
            </a:r>
            <a:endParaRPr kumimoji="0" lang="ko-KR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15" name="그룹 14"/>
          <p:cNvGrpSpPr/>
          <p:nvPr/>
        </p:nvGrpSpPr>
        <p:grpSpPr>
          <a:xfrm>
            <a:off x="338303" y="6202946"/>
            <a:ext cx="3087568" cy="2156686"/>
            <a:chOff x="3338336" y="3835584"/>
            <a:chExt cx="3087568" cy="2156686"/>
          </a:xfrm>
        </p:grpSpPr>
        <p:pic>
          <p:nvPicPr>
            <p:cNvPr id="18" name="그림 17"/>
            <p:cNvPicPr>
              <a:picLocks noChangeAspect="1"/>
            </p:cNvPicPr>
            <p:nvPr/>
          </p:nvPicPr>
          <p:blipFill rotWithShape="1">
            <a:blip r:embed="rId6"/>
            <a:srcRect t="28050"/>
            <a:stretch/>
          </p:blipFill>
          <p:spPr>
            <a:xfrm>
              <a:off x="6045448" y="3835584"/>
              <a:ext cx="368346" cy="187961"/>
            </a:xfrm>
            <a:prstGeom prst="rect">
              <a:avLst/>
            </a:prstGeom>
          </p:spPr>
        </p:pic>
        <p:grpSp>
          <p:nvGrpSpPr>
            <p:cNvPr id="19" name="그룹 18"/>
            <p:cNvGrpSpPr/>
            <p:nvPr/>
          </p:nvGrpSpPr>
          <p:grpSpPr>
            <a:xfrm>
              <a:off x="3338336" y="4025066"/>
              <a:ext cx="3087568" cy="1967204"/>
              <a:chOff x="3344870" y="3839526"/>
              <a:chExt cx="3087568" cy="1967204"/>
            </a:xfrm>
          </p:grpSpPr>
          <p:pic>
            <p:nvPicPr>
              <p:cNvPr id="20" name="그림 19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344870" y="3839526"/>
                <a:ext cx="3075246" cy="1209933"/>
              </a:xfrm>
              <a:prstGeom prst="rect">
                <a:avLst/>
              </a:prstGeom>
            </p:spPr>
          </p:pic>
          <p:sp>
            <p:nvSpPr>
              <p:cNvPr id="21" name="TextBox 20"/>
              <p:cNvSpPr txBox="1"/>
              <p:nvPr/>
            </p:nvSpPr>
            <p:spPr>
              <a:xfrm rot="16200000" flipH="1">
                <a:off x="336918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04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 flipH="1">
                <a:off x="457671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62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 flipH="1">
                <a:off x="5918411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153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6200000" flipH="1">
                <a:off x="511339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73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6200000" flipH="1">
                <a:off x="497922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72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 flipH="1">
                <a:off x="551590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119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6200000" flipH="1">
                <a:off x="471088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63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6200000" flipH="1">
                <a:off x="524756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88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6200000" flipH="1">
                <a:off x="377169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09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6200000" flipH="1">
                <a:off x="417420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24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6200000" flipH="1">
                <a:off x="565007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125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16200000" flipH="1">
                <a:off x="404003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22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6200000" flipH="1">
                <a:off x="390586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13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16200000" flipH="1">
                <a:off x="538173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95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6200000" flipH="1">
                <a:off x="444254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47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6200000" flipH="1">
                <a:off x="430837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26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6200000" flipH="1">
                <a:off x="350335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07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6200000" flipH="1">
                <a:off x="578424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132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6200000" flipH="1">
                <a:off x="484505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70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6200000" flipH="1">
                <a:off x="3637524" y="5292702"/>
                <a:ext cx="82800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CRCD0008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357824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125896" y="96029"/>
            <a:ext cx="67321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PI3K/</a:t>
            </a:r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 signaling pathway in the Kyoto Encyclopedia of Genes and Genomes (KEGG) pathway analysis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564874" y="1190699"/>
            <a:ext cx="5854148" cy="4551436"/>
            <a:chOff x="564874" y="1003129"/>
            <a:chExt cx="5854148" cy="4551436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4874" y="1003129"/>
              <a:ext cx="5854148" cy="4367611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564874" y="5339121"/>
              <a:ext cx="30792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Stars indicate differentially expressed gene in RNA-</a:t>
              </a:r>
              <a:r>
                <a:rPr lang="en-US" altLang="ko-K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 data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506144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125896" y="96029"/>
            <a:ext cx="67321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Amino acid sequence alignment of PIK3CA in human and dog.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그룹 13"/>
          <p:cNvGrpSpPr/>
          <p:nvPr/>
        </p:nvGrpSpPr>
        <p:grpSpPr>
          <a:xfrm>
            <a:off x="125896" y="927026"/>
            <a:ext cx="4744091" cy="5885491"/>
            <a:chOff x="208689" y="927026"/>
            <a:chExt cx="4744091" cy="5885491"/>
          </a:xfrm>
        </p:grpSpPr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39558" y="927026"/>
              <a:ext cx="3713222" cy="5885491"/>
            </a:xfrm>
            <a:prstGeom prst="rect">
              <a:avLst/>
            </a:prstGeom>
          </p:spPr>
        </p:pic>
        <p:cxnSp>
          <p:nvCxnSpPr>
            <p:cNvPr id="9" name="직선 화살표 연결선 8"/>
            <p:cNvCxnSpPr/>
            <p:nvPr/>
          </p:nvCxnSpPr>
          <p:spPr>
            <a:xfrm>
              <a:off x="984493" y="1244600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208689" y="1141958"/>
              <a:ext cx="9307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Human PIK3CA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직선 화살표 연결선 11"/>
            <p:cNvCxnSpPr/>
            <p:nvPr/>
          </p:nvCxnSpPr>
          <p:spPr>
            <a:xfrm>
              <a:off x="984493" y="1398563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308814" y="1298535"/>
              <a:ext cx="7304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Dog PIK3CA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직사각형 10"/>
            <p:cNvSpPr/>
            <p:nvPr/>
          </p:nvSpPr>
          <p:spPr>
            <a:xfrm>
              <a:off x="3987800" y="3699591"/>
              <a:ext cx="228600" cy="242489"/>
            </a:xfrm>
            <a:prstGeom prst="rect">
              <a:avLst/>
            </a:prstGeom>
            <a:solidFill>
              <a:srgbClr val="FFFF00">
                <a:alpha val="3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3258531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122597" y="86708"/>
            <a:ext cx="633735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KM plot analysis for SMGs in CMT but have not been studied in HB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그룹 46"/>
          <p:cNvGrpSpPr/>
          <p:nvPr/>
        </p:nvGrpSpPr>
        <p:grpSpPr>
          <a:xfrm>
            <a:off x="264241" y="967133"/>
            <a:ext cx="4616771" cy="3958434"/>
            <a:chOff x="265201" y="1208686"/>
            <a:chExt cx="4616771" cy="3958434"/>
          </a:xfrm>
        </p:grpSpPr>
        <p:grpSp>
          <p:nvGrpSpPr>
            <p:cNvPr id="46" name="그룹 45"/>
            <p:cNvGrpSpPr/>
            <p:nvPr/>
          </p:nvGrpSpPr>
          <p:grpSpPr>
            <a:xfrm>
              <a:off x="265201" y="3259474"/>
              <a:ext cx="4616771" cy="1907646"/>
              <a:chOff x="265201" y="3561032"/>
              <a:chExt cx="4616771" cy="1907646"/>
            </a:xfrm>
          </p:grpSpPr>
          <p:grpSp>
            <p:nvGrpSpPr>
              <p:cNvPr id="39" name="그룹 38"/>
              <p:cNvGrpSpPr/>
              <p:nvPr/>
            </p:nvGrpSpPr>
            <p:grpSpPr>
              <a:xfrm>
                <a:off x="265201" y="3561032"/>
                <a:ext cx="1497600" cy="1907646"/>
                <a:chOff x="-3347126" y="3050333"/>
                <a:chExt cx="1497600" cy="1907646"/>
              </a:xfrm>
            </p:grpSpPr>
            <p:pic>
              <p:nvPicPr>
                <p:cNvPr id="4" name="그림 3"/>
                <p:cNvPicPr preferRelativeResize="0">
                  <a:picLocks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3347126" y="3305579"/>
                  <a:ext cx="1497600" cy="1652400"/>
                </a:xfrm>
                <a:prstGeom prst="rect">
                  <a:avLst/>
                </a:prstGeom>
              </p:spPr>
            </p:pic>
            <p:sp>
              <p:nvSpPr>
                <p:cNvPr id="67" name="TextBox 66"/>
                <p:cNvSpPr txBox="1"/>
                <p:nvPr/>
              </p:nvSpPr>
              <p:spPr>
                <a:xfrm>
                  <a:off x="-3115940" y="3050333"/>
                  <a:ext cx="117071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KD1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8" name="그룹 37"/>
              <p:cNvGrpSpPr/>
              <p:nvPr/>
            </p:nvGrpSpPr>
            <p:grpSpPr>
              <a:xfrm>
                <a:off x="1822530" y="3561032"/>
                <a:ext cx="1497600" cy="1905657"/>
                <a:chOff x="-1638388" y="3107486"/>
                <a:chExt cx="1497600" cy="1905657"/>
              </a:xfrm>
            </p:grpSpPr>
            <p:pic>
              <p:nvPicPr>
                <p:cNvPr id="21" name="그림 20"/>
                <p:cNvPicPr preferRelativeResize="0">
                  <a:picLocks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638388" y="3360743"/>
                  <a:ext cx="1497600" cy="1652400"/>
                </a:xfrm>
                <a:prstGeom prst="rect">
                  <a:avLst/>
                </a:prstGeom>
              </p:spPr>
            </p:pic>
            <p:sp>
              <p:nvSpPr>
                <p:cNvPr id="68" name="TextBox 67"/>
                <p:cNvSpPr txBox="1"/>
                <p:nvPr/>
              </p:nvSpPr>
              <p:spPr>
                <a:xfrm>
                  <a:off x="-1405895" y="3107486"/>
                  <a:ext cx="117071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LY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3" name="그룹 32"/>
              <p:cNvGrpSpPr/>
              <p:nvPr/>
            </p:nvGrpSpPr>
            <p:grpSpPr>
              <a:xfrm>
                <a:off x="3384372" y="3561032"/>
                <a:ext cx="1497600" cy="1905083"/>
                <a:chOff x="-3394607" y="-93333"/>
                <a:chExt cx="1497600" cy="1905083"/>
              </a:xfrm>
            </p:grpSpPr>
            <p:pic>
              <p:nvPicPr>
                <p:cNvPr id="16" name="그림 15"/>
                <p:cNvPicPr preferRelativeResize="0">
                  <a:picLocks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3394607" y="159350"/>
                  <a:ext cx="1497600" cy="1652400"/>
                </a:xfrm>
                <a:prstGeom prst="rect">
                  <a:avLst/>
                </a:prstGeom>
              </p:spPr>
            </p:pic>
            <p:sp>
              <p:nvSpPr>
                <p:cNvPr id="69" name="TextBox 68"/>
                <p:cNvSpPr txBox="1"/>
                <p:nvPr/>
              </p:nvSpPr>
              <p:spPr>
                <a:xfrm>
                  <a:off x="-3165320" y="-93333"/>
                  <a:ext cx="117071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X8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43" name="그룹 42"/>
            <p:cNvGrpSpPr/>
            <p:nvPr/>
          </p:nvGrpSpPr>
          <p:grpSpPr>
            <a:xfrm>
              <a:off x="265201" y="1208686"/>
              <a:ext cx="4616771" cy="1928033"/>
              <a:chOff x="265201" y="1208686"/>
              <a:chExt cx="4616771" cy="1928033"/>
            </a:xfrm>
          </p:grpSpPr>
          <p:grpSp>
            <p:nvGrpSpPr>
              <p:cNvPr id="23" name="그룹 22"/>
              <p:cNvGrpSpPr/>
              <p:nvPr/>
            </p:nvGrpSpPr>
            <p:grpSpPr>
              <a:xfrm>
                <a:off x="265201" y="1208686"/>
                <a:ext cx="1497600" cy="1928033"/>
                <a:chOff x="-3397054" y="985550"/>
                <a:chExt cx="1497600" cy="1928033"/>
              </a:xfrm>
            </p:grpSpPr>
            <p:pic>
              <p:nvPicPr>
                <p:cNvPr id="5" name="그림 4"/>
                <p:cNvPicPr preferRelativeResize="0">
                  <a:picLocks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3397054" y="1261183"/>
                  <a:ext cx="1497600" cy="1652400"/>
                </a:xfrm>
                <a:prstGeom prst="rect">
                  <a:avLst/>
                </a:prstGeom>
              </p:spPr>
            </p:pic>
            <p:sp>
              <p:nvSpPr>
                <p:cNvPr id="55" name="TextBox 54"/>
                <p:cNvSpPr txBox="1"/>
                <p:nvPr/>
              </p:nvSpPr>
              <p:spPr>
                <a:xfrm>
                  <a:off x="-3165868" y="985550"/>
                  <a:ext cx="117071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M3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2" name="그룹 21"/>
              <p:cNvGrpSpPr/>
              <p:nvPr/>
            </p:nvGrpSpPr>
            <p:grpSpPr>
              <a:xfrm>
                <a:off x="3384372" y="1208686"/>
                <a:ext cx="1497600" cy="1914010"/>
                <a:chOff x="-1761376" y="945590"/>
                <a:chExt cx="1497600" cy="1914010"/>
              </a:xfrm>
            </p:grpSpPr>
            <p:pic>
              <p:nvPicPr>
                <p:cNvPr id="20" name="그림 19"/>
                <p:cNvPicPr preferRelativeResize="0">
                  <a:picLocks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761376" y="1207200"/>
                  <a:ext cx="1497600" cy="1652400"/>
                </a:xfrm>
                <a:prstGeom prst="rect">
                  <a:avLst/>
                </a:prstGeom>
              </p:spPr>
            </p:pic>
            <p:sp>
              <p:nvSpPr>
                <p:cNvPr id="65" name="TextBox 64"/>
                <p:cNvSpPr txBox="1"/>
                <p:nvPr/>
              </p:nvSpPr>
              <p:spPr>
                <a:xfrm>
                  <a:off x="-1532089" y="945590"/>
                  <a:ext cx="117071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29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2" name="그룹 31"/>
              <p:cNvGrpSpPr/>
              <p:nvPr/>
            </p:nvGrpSpPr>
            <p:grpSpPr>
              <a:xfrm>
                <a:off x="1822360" y="1208686"/>
                <a:ext cx="1497600" cy="1909747"/>
                <a:chOff x="-1991503" y="97389"/>
                <a:chExt cx="1497600" cy="1909747"/>
              </a:xfrm>
            </p:grpSpPr>
            <p:pic>
              <p:nvPicPr>
                <p:cNvPr id="2" name="그림 1"/>
                <p:cNvPicPr preferRelativeResize="0">
                  <a:picLocks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1991503" y="354736"/>
                  <a:ext cx="1497600" cy="1652400"/>
                </a:xfrm>
                <a:prstGeom prst="rect">
                  <a:avLst/>
                </a:prstGeom>
              </p:spPr>
            </p:pic>
            <p:sp>
              <p:nvSpPr>
                <p:cNvPr id="66" name="TextBox 65"/>
                <p:cNvSpPr txBox="1"/>
                <p:nvPr/>
              </p:nvSpPr>
              <p:spPr>
                <a:xfrm>
                  <a:off x="-1758839" y="97389"/>
                  <a:ext cx="117071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RD6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066180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555</TotalTime>
  <Words>107</Words>
  <Application>Microsoft Office PowerPoint</Application>
  <PresentationFormat>A4 용지(210x297mm)</PresentationFormat>
  <Paragraphs>37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</dc:creator>
  <cp:lastModifiedBy>Lee</cp:lastModifiedBy>
  <cp:revision>422</cp:revision>
  <cp:lastPrinted>2019-07-30T08:57:19Z</cp:lastPrinted>
  <dcterms:created xsi:type="dcterms:W3CDTF">2019-01-23T06:09:49Z</dcterms:created>
  <dcterms:modified xsi:type="dcterms:W3CDTF">2019-11-07T07:26:12Z</dcterms:modified>
</cp:coreProperties>
</file>